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73576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9715FC-A9B5-424C-A244-2E01E3CEDC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C97E60-AED9-466B-BE6A-3480E6F3C9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956EA8-8540-4CC1-BBD2-C8091A8C08B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4908BC-3A69-46D3-9689-1AF2703A7DB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AEDA74-5350-467A-8E86-EBE5745CA8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8FC1CA-E827-4ED6-B250-B90577E4BE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7F39A6-C2E5-43C1-AB48-6D54E1FB8C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66A278-B536-4ECF-B66F-22294C4D13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4339BA-B83E-4ED7-9949-4A1A971407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18C034-D9BC-44F8-A9F4-80769153F3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6FD5E7-DC86-4BFA-90EA-3CF1FAE14C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0CBF3F-7A31-4442-B1E7-55A7A58548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349072-005A-48CD-8319-FCF3C917EC5A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ｲﾒｰｼﾞ_927" descr=""/>
          <p:cNvPicPr/>
          <p:nvPr/>
        </p:nvPicPr>
        <p:blipFill>
          <a:blip r:embed="rId1"/>
          <a:srcRect l="0" t="0" r="0" b="4887"/>
          <a:stretch/>
        </p:blipFill>
        <p:spPr>
          <a:xfrm>
            <a:off x="1600200" y="1143000"/>
            <a:ext cx="6172200" cy="44197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54440" y="6369120"/>
            <a:ext cx="77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Fig. S1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6936120" y="5149800"/>
            <a:ext cx="727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3333cc"/>
                </a:solidFill>
                <a:latin typeface="Times New Roman"/>
              </a:rPr>
              <a:t>50 </a:t>
            </a:r>
            <a:r>
              <a:rPr b="1" lang="en-US" sz="1600" spc="-1" strike="noStrike">
                <a:solidFill>
                  <a:srgbClr val="3333cc"/>
                </a:solidFill>
                <a:latin typeface="Arial"/>
                <a:ea typeface="Arial"/>
              </a:rPr>
              <a:t>μ</a:t>
            </a:r>
            <a:r>
              <a:rPr b="1" lang="en-US" sz="1600" spc="-1" strike="noStrike">
                <a:solidFill>
                  <a:srgbClr val="3333cc"/>
                </a:solidFill>
                <a:latin typeface="Times New Roman"/>
              </a:rPr>
              <a:t>m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6934320" y="5486400"/>
            <a:ext cx="701640" cy="0"/>
          </a:xfrm>
          <a:prstGeom prst="line">
            <a:avLst/>
          </a:prstGeom>
          <a:ln w="381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"/>
          <p:cNvSpPr/>
          <p:nvPr/>
        </p:nvSpPr>
        <p:spPr>
          <a:xfrm>
            <a:off x="228600" y="228600"/>
            <a:ext cx="86104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Times New Roman"/>
              </a:rPr>
              <a:t>Fig. S1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olony morphology of group G strains in field water samples.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A small number of relatively large cells (5.5–7.5 μm) loosely aggregated to form irregular small colonies, but never formed the large sponge-like structure that was previously identified as </a:t>
            </a:r>
            <a:r>
              <a:rPr b="0" i="1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Microcystis aeruginosa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(</a:t>
            </a:r>
            <a:r>
              <a:rPr b="0" i="1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sensu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Komárek, 1991). In culture, however, we observed that it sometimes formed larger colonies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228600" y="1523880"/>
            <a:ext cx="86104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Times New Roman"/>
              </a:rPr>
              <a:t>Reference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Komárek, J. (1991). A review of water-bloom forming </a:t>
            </a:r>
            <a:r>
              <a:rPr b="0" i="1" lang="ja-JP" sz="1200" spc="-1" strike="noStrike">
                <a:solidFill>
                  <a:srgbClr val="000000"/>
                </a:solidFill>
                <a:latin typeface="Times New Roman"/>
              </a:rPr>
              <a:t>Microcystis 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species, with regard to populations from Japan. </a:t>
            </a:r>
            <a:r>
              <a:rPr b="0" i="1" lang="ja-JP" sz="1200" spc="-1" strike="noStrike">
                <a:solidFill>
                  <a:srgbClr val="000000"/>
                </a:solidFill>
                <a:latin typeface="Times New Roman"/>
              </a:rPr>
              <a:t>Arch Hydrobiol Suppl Algol Stud.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</a:rPr>
              <a:t>64: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 115–127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0T06:47:08Z</dcterms:created>
  <dc:creator>YT</dc:creator>
  <dc:description/>
  <dc:language>en-US</dc:language>
  <cp:lastModifiedBy>YT</cp:lastModifiedBy>
  <dcterms:modified xsi:type="dcterms:W3CDTF">2010-11-08T06:35:45Z</dcterms:modified>
  <cp:revision>53</cp:revision>
  <dc:subject/>
  <dc:title>PowerPoint プレゼンテーション</dc:title>
</cp:coreProperties>
</file>